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81868" autoAdjust="0"/>
  </p:normalViewPr>
  <p:slideViewPr>
    <p:cSldViewPr snapToGrid="0">
      <p:cViewPr varScale="1">
        <p:scale>
          <a:sx n="81" d="100"/>
          <a:sy n="81" d="100"/>
        </p:scale>
        <p:origin x="66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E0D071-E014-407C-8D2A-5C2EC3719938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2738AD-3EC3-454C-890C-B086528CD2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860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/>
            </a:r>
            <a:b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</a:b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2738AD-3EC3-454C-890C-B086528CD2B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3172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034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377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442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375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1280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64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436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22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542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441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03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87831-1A09-44F6-BF19-5EDE7B8E53B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25F279-3CD8-42EA-B142-578D67408E4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022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5903910"/>
              </p:ext>
            </p:extLst>
          </p:nvPr>
        </p:nvGraphicFramePr>
        <p:xfrm>
          <a:off x="869740" y="819989"/>
          <a:ext cx="10391667" cy="5571349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09015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3453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6113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851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arget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2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old change</a:t>
                      </a:r>
                      <a:endParaRPr lang="is-I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unctio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2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regulation</a:t>
                      </a:r>
                      <a:endParaRPr lang="mr-IN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binding protein 3 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7.80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metabolism, PPAR ligand transport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δ</a:t>
                      </a:r>
                      <a:r>
                        <a:rPr lang="en-US" sz="1200" b="1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mr-IN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ipoprotein lipas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47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dipogenesis, Lipid </a:t>
                      </a:r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etabolism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1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Uncoupling protein 1 </a:t>
                      </a:r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(UCP1)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3.25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rown fat function, energetics 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1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1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hromodomain helicase DNA binding protein 9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7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-factor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arnitine palmitoyltransferase 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7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metabolism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36 antige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6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ligand transport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lasti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6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ell prolifer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p300 E1A binding protein p300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5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-factor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N/A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uclear receptor coactivator 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5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</a:t>
                      </a: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-factor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N/A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ypoxia </a:t>
                      </a: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ducible factor 1, alpha subuni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ell prolifer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mr-IN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arnitine palmitoyltransferase 1b (muscle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metabolism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Integrin linked kinase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ell prolifer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mr-IN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olute carrier family 27 (fatty acid transporter), member 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metabolism, PPAR ligand transpor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mr-IN" sz="1200" b="0" i="0" u="none" strike="noStrike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binding protein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7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  <a:endParaRPr lang="nb-NO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ligand transpor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N/A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Matrix metallopeptidase 9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Breakdown of extracellular matri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Helicase zinc finger 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  <a:endParaRPr lang="nb-NO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ranscriptional coactivator</a:t>
                      </a:r>
                      <a:r>
                        <a:rPr lang="en-US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for PPAR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diponectin, C1Q and collagen domain contain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dipogenesis, Lipid transpor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cyl-CoA synthetase long-chain family member 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4</a:t>
                      </a:r>
                      <a:endParaRPr lang="nb-NO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</a:t>
                      </a:r>
                      <a:r>
                        <a:rPr lang="en-US" sz="12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metabolis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hosphoenolpyruvate carboxykinase 2 (mitochondrial)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3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Other PPAR G target gen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olute carrier family 27 (fatty acid transporter), member 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1</a:t>
                      </a:r>
                    </a:p>
                  </a:txBody>
                  <a:tcPr marL="12700" marR="12700" marT="12700" marB="0">
                    <a:solidFill>
                      <a:srgbClr val="00B05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>
                        <a:lnSpc>
                          <a:spcPct val="100000"/>
                        </a:lnSpc>
                      </a:pPr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ligand transport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/>
                </a:tc>
                <a:tc>
                  <a:txBody>
                    <a:bodyPr/>
                    <a:lstStyle/>
                    <a:p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</a:t>
                      </a:r>
                      <a:endParaRPr lang="en-US" sz="1200" kern="1200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1831" marR="11831" marT="11831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hospholipid transfer protein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4</a:t>
                      </a:r>
                    </a:p>
                  </a:txBody>
                  <a:tcPr marL="12700" marR="12700" marT="12700" marB="0" anchor="b">
                    <a:solidFill>
                      <a:srgbClr val="C0000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metabolism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Oxidized low density lipoprotein (lectin-like) receptor 1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4</a:t>
                      </a:r>
                    </a:p>
                  </a:txBody>
                  <a:tcPr marL="12700" marR="12700" marT="12700" marB="0" anchor="b">
                    <a:solidFill>
                      <a:srgbClr val="C0000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ipid transport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ngiopoietin-like 4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3</a:t>
                      </a:r>
                    </a:p>
                  </a:txBody>
                  <a:tcPr marL="12700" marR="12700" marT="12700" marB="0" anchor="b">
                    <a:solidFill>
                      <a:srgbClr val="C0000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ipid transport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Acyl-CoA synthetase long-chain family member 5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3</a:t>
                      </a:r>
                    </a:p>
                  </a:txBody>
                  <a:tcPr marL="12700" marR="12700" marT="12700" marB="0" anchor="b">
                    <a:solidFill>
                      <a:srgbClr val="C0000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metabolism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Enoyl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Coenzyme A, hydratase/3-hydroxyacyl Coenzyme A dehydrogena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3</a:t>
                      </a:r>
                      <a:endParaRPr lang="nb-NO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>
                    <a:solidFill>
                      <a:srgbClr val="C0000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metabolism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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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, </a:t>
                      </a:r>
                      <a:r>
                        <a:rPr lang="en-US" sz="120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  <a:sym typeface="Symbol" charset="2"/>
                        </a:rPr>
                        <a:t>, </a:t>
                      </a:r>
                      <a:r>
                        <a:rPr lang="en-US" sz="1200" b="0" kern="1200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δ</a:t>
                      </a:r>
                      <a:r>
                        <a:rPr lang="en-US" sz="1200" b="0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en-US" sz="1200" kern="1200" dirty="0" smtClean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9947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atty acid binding protein 5 </a:t>
                      </a: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3</a:t>
                      </a:r>
                    </a:p>
                  </a:txBody>
                  <a:tcPr marL="12700" marR="12700" marT="12700" marB="0" anchor="b">
                    <a:solidFill>
                      <a:srgbClr val="C00000">
                        <a:alpha val="50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PAR ligand transport </a:t>
                      </a: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/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12700" marR="12700" marT="12700" marB="0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95672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93</TotalTime>
  <Words>362</Words>
  <Application>Microsoft Office PowerPoint</Application>
  <PresentationFormat>Widescreen</PresentationFormat>
  <Paragraphs>1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en Houseknecht</dc:creator>
  <cp:lastModifiedBy>Karen Houseknecht</cp:lastModifiedBy>
  <cp:revision>10</cp:revision>
  <dcterms:created xsi:type="dcterms:W3CDTF">2020-11-25T17:41:37Z</dcterms:created>
  <dcterms:modified xsi:type="dcterms:W3CDTF">2020-11-30T20:55:07Z</dcterms:modified>
</cp:coreProperties>
</file>